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7" r:id="rId2"/>
    <p:sldId id="258" r:id="rId3"/>
    <p:sldId id="259" r:id="rId4"/>
    <p:sldId id="260" r:id="rId5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310"/>
    <p:restoredTop sz="94729"/>
  </p:normalViewPr>
  <p:slideViewPr>
    <p:cSldViewPr snapToGrid="0">
      <p:cViewPr varScale="1">
        <p:scale>
          <a:sx n="58" d="100"/>
          <a:sy n="58" d="100"/>
        </p:scale>
        <p:origin x="3176" y="2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87B71F-6BB6-FC48-ACDC-AC90B10572DE}" type="datetimeFigureOut">
              <a:rPr kumimoji="1" lang="ja-JP" altLang="en-US" smtClean="0"/>
              <a:t>2025/9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9BF1A-317D-5247-B06F-CD58F85F238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37669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87B71F-6BB6-FC48-ACDC-AC90B10572DE}" type="datetimeFigureOut">
              <a:rPr kumimoji="1" lang="ja-JP" altLang="en-US" smtClean="0"/>
              <a:t>2025/9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9BF1A-317D-5247-B06F-CD58F85F238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1000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87B71F-6BB6-FC48-ACDC-AC90B10572DE}" type="datetimeFigureOut">
              <a:rPr kumimoji="1" lang="ja-JP" altLang="en-US" smtClean="0"/>
              <a:t>2025/9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9BF1A-317D-5247-B06F-CD58F85F238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3953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87B71F-6BB6-FC48-ACDC-AC90B10572DE}" type="datetimeFigureOut">
              <a:rPr kumimoji="1" lang="ja-JP" altLang="en-US" smtClean="0"/>
              <a:t>2025/9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9BF1A-317D-5247-B06F-CD58F85F238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12491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87B71F-6BB6-FC48-ACDC-AC90B10572DE}" type="datetimeFigureOut">
              <a:rPr kumimoji="1" lang="ja-JP" altLang="en-US" smtClean="0"/>
              <a:t>2025/9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9BF1A-317D-5247-B06F-CD58F85F238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30160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87B71F-6BB6-FC48-ACDC-AC90B10572DE}" type="datetimeFigureOut">
              <a:rPr kumimoji="1" lang="ja-JP" altLang="en-US" smtClean="0"/>
              <a:t>2025/9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9BF1A-317D-5247-B06F-CD58F85F238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17131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87B71F-6BB6-FC48-ACDC-AC90B10572DE}" type="datetimeFigureOut">
              <a:rPr kumimoji="1" lang="ja-JP" altLang="en-US" smtClean="0"/>
              <a:t>2025/9/1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9BF1A-317D-5247-B06F-CD58F85F238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66415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87B71F-6BB6-FC48-ACDC-AC90B10572DE}" type="datetimeFigureOut">
              <a:rPr kumimoji="1" lang="ja-JP" altLang="en-US" smtClean="0"/>
              <a:t>2025/9/1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9BF1A-317D-5247-B06F-CD58F85F238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86475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87B71F-6BB6-FC48-ACDC-AC90B10572DE}" type="datetimeFigureOut">
              <a:rPr kumimoji="1" lang="ja-JP" altLang="en-US" smtClean="0"/>
              <a:t>2025/9/1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9BF1A-317D-5247-B06F-CD58F85F238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40118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87B71F-6BB6-FC48-ACDC-AC90B10572DE}" type="datetimeFigureOut">
              <a:rPr kumimoji="1" lang="ja-JP" altLang="en-US" smtClean="0"/>
              <a:t>2025/9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9BF1A-317D-5247-B06F-CD58F85F238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9035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87B71F-6BB6-FC48-ACDC-AC90B10572DE}" type="datetimeFigureOut">
              <a:rPr kumimoji="1" lang="ja-JP" altLang="en-US" smtClean="0"/>
              <a:t>2025/9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9BF1A-317D-5247-B06F-CD58F85F238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83792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87B71F-6BB6-FC48-ACDC-AC90B10572DE}" type="datetimeFigureOut">
              <a:rPr kumimoji="1" lang="ja-JP" altLang="en-US" smtClean="0"/>
              <a:t>2025/9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F9BF1A-317D-5247-B06F-CD58F85F238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55783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A7E1EDA0-2B61-D33B-B528-FC6F31AF2758}"/>
              </a:ext>
            </a:extLst>
          </p:cNvPr>
          <p:cNvSpPr txBox="1"/>
          <p:nvPr/>
        </p:nvSpPr>
        <p:spPr>
          <a:xfrm>
            <a:off x="1206309" y="94431"/>
            <a:ext cx="44100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Palatino Linotype" panose="02040502050505030304" pitchFamily="18" charset="0"/>
                <a:ea typeface="ＭＳ ゴシック" panose="020B0609070205080204" pitchFamily="49" charset="-128"/>
                <a:cs typeface="Arial" panose="020B0604020202020204" pitchFamily="34" charset="0"/>
              </a:rPr>
              <a:t>Table S1. </a:t>
            </a:r>
            <a:r>
              <a:rPr lang="en-US" altLang="ja-JP" sz="14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Results of tests on normality of data</a:t>
            </a:r>
            <a:r>
              <a:rPr lang="ja-JP" altLang="ja-JP" sz="1400"/>
              <a:t> </a:t>
            </a:r>
            <a:endParaRPr lang="ja-JP" altLang="en-US" sz="1400" dirty="0">
              <a:latin typeface="Palatino Linotype" panose="02040502050505030304" pitchFamily="18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62E6511C-25AA-2E57-6229-64EAEB5E4941}"/>
              </a:ext>
            </a:extLst>
          </p:cNvPr>
          <p:cNvSpPr txBox="1"/>
          <p:nvPr/>
        </p:nvSpPr>
        <p:spPr>
          <a:xfrm>
            <a:off x="1433232" y="11574349"/>
            <a:ext cx="395624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" altLang="ja-JP" sz="1400" dirty="0">
                <a:latin typeface="Palatino Linotype" panose="02040502050505030304" pitchFamily="18" charset="0"/>
              </a:rPr>
              <a:t>*. This is a lower bound of the true significance.</a:t>
            </a:r>
          </a:p>
          <a:p>
            <a:r>
              <a:rPr lang="en" altLang="ja-JP" sz="1400" dirty="0">
                <a:latin typeface="Palatino Linotype" panose="02040502050505030304" pitchFamily="18" charset="0"/>
              </a:rPr>
              <a:t>a. Lilliefors Significance Correction</a:t>
            </a:r>
            <a:endParaRPr lang="ja-JP" altLang="en-US" sz="1400">
              <a:latin typeface="Palatino Linotype" panose="02040502050505030304" pitchFamily="18" charset="0"/>
            </a:endParaRPr>
          </a:p>
        </p:txBody>
      </p:sp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7B0A2B11-382E-126D-B68C-3FDBCCDBEB2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63823561"/>
              </p:ext>
            </p:extLst>
          </p:nvPr>
        </p:nvGraphicFramePr>
        <p:xfrm>
          <a:off x="607876" y="509929"/>
          <a:ext cx="5606954" cy="10970686"/>
        </p:xfrm>
        <a:graphic>
          <a:graphicData uri="http://schemas.openxmlformats.org/drawingml/2006/table">
            <a:tbl>
              <a:tblPr/>
              <a:tblGrid>
                <a:gridCol w="1828800">
                  <a:extLst>
                    <a:ext uri="{9D8B030D-6E8A-4147-A177-3AD203B41FA5}">
                      <a16:colId xmlns:a16="http://schemas.microsoft.com/office/drawing/2014/main" val="2340706099"/>
                    </a:ext>
                  </a:extLst>
                </a:gridCol>
                <a:gridCol w="1117600">
                  <a:extLst>
                    <a:ext uri="{9D8B030D-6E8A-4147-A177-3AD203B41FA5}">
                      <a16:colId xmlns:a16="http://schemas.microsoft.com/office/drawing/2014/main" val="3268929165"/>
                    </a:ext>
                  </a:extLst>
                </a:gridCol>
                <a:gridCol w="1158240">
                  <a:extLst>
                    <a:ext uri="{9D8B030D-6E8A-4147-A177-3AD203B41FA5}">
                      <a16:colId xmlns:a16="http://schemas.microsoft.com/office/drawing/2014/main" val="746970114"/>
                    </a:ext>
                  </a:extLst>
                </a:gridCol>
                <a:gridCol w="1502314">
                  <a:extLst>
                    <a:ext uri="{9D8B030D-6E8A-4147-A177-3AD203B41FA5}">
                      <a16:colId xmlns:a16="http://schemas.microsoft.com/office/drawing/2014/main" val="2728293749"/>
                    </a:ext>
                  </a:extLst>
                </a:gridCol>
              </a:tblGrid>
              <a:tr h="152549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ja-JP" altLang="en-US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　</a:t>
                      </a:r>
                    </a:p>
                  </a:txBody>
                  <a:tcPr marL="2172" marR="2172" marT="217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Shapiro-Wilk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84709099"/>
                  </a:ext>
                </a:extLst>
              </a:tr>
              <a:tr h="202305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Statistic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df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Sig.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45966924"/>
                  </a:ext>
                </a:extLst>
              </a:tr>
              <a:tr h="152549"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Lo line</a:t>
                      </a:r>
                    </a:p>
                  </a:txBody>
                  <a:tcPr marL="2172" marR="2172" marT="217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970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33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483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00503338"/>
                  </a:ext>
                </a:extLst>
              </a:tr>
              <a:tr h="303056"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FP</a:t>
                      </a:r>
                      <a:b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</a:br>
                      <a: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(a)</a:t>
                      </a:r>
                    </a:p>
                  </a:txBody>
                  <a:tcPr marL="2172" marR="2172" marT="217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974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33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597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62919319"/>
                  </a:ext>
                </a:extLst>
              </a:tr>
              <a:tr h="303056"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FP</a:t>
                      </a:r>
                      <a:b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</a:br>
                      <a: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(b)</a:t>
                      </a:r>
                    </a:p>
                  </a:txBody>
                  <a:tcPr marL="2172" marR="2172" marT="217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980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33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784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22327876"/>
                  </a:ext>
                </a:extLst>
              </a:tr>
              <a:tr h="152549"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FP diff</a:t>
                      </a:r>
                    </a:p>
                  </a:txBody>
                  <a:tcPr marL="2172" marR="2172" marT="217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984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33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888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10236292"/>
                  </a:ext>
                </a:extLst>
              </a:tr>
              <a:tr h="303056"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Lo line-J</a:t>
                      </a:r>
                      <a:b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</a:br>
                      <a: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(a)</a:t>
                      </a:r>
                    </a:p>
                  </a:txBody>
                  <a:tcPr marL="2172" marR="2172" marT="217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969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33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450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23769929"/>
                  </a:ext>
                </a:extLst>
              </a:tr>
              <a:tr h="303056"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Lo line-J</a:t>
                      </a:r>
                      <a:b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</a:br>
                      <a: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(b)</a:t>
                      </a:r>
                    </a:p>
                  </a:txBody>
                  <a:tcPr marL="2172" marR="2172" marT="217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978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33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708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59374380"/>
                  </a:ext>
                </a:extLst>
              </a:tr>
              <a:tr h="303056"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Lo-line-J</a:t>
                      </a:r>
                      <a:b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</a:br>
                      <a: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diff</a:t>
                      </a:r>
                    </a:p>
                  </a:txBody>
                  <a:tcPr marL="2172" marR="2172" marT="217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977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33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697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196099"/>
                  </a:ext>
                </a:extLst>
              </a:tr>
              <a:tr h="361852"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Lo line-Mo</a:t>
                      </a:r>
                      <a:b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</a:br>
                      <a: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(a)</a:t>
                      </a:r>
                    </a:p>
                  </a:txBody>
                  <a:tcPr marL="2172" marR="2172" marT="217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989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33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984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00678758"/>
                  </a:ext>
                </a:extLst>
              </a:tr>
              <a:tr h="361852"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Lo line-Mo</a:t>
                      </a:r>
                      <a:b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</a:br>
                      <a: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(b)</a:t>
                      </a:r>
                    </a:p>
                  </a:txBody>
                  <a:tcPr marL="2172" marR="2172" marT="217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991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33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995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11605765"/>
                  </a:ext>
                </a:extLst>
              </a:tr>
              <a:tr h="361852"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Lo line-Mo</a:t>
                      </a:r>
                      <a:b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</a:br>
                      <a: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diff</a:t>
                      </a:r>
                    </a:p>
                  </a:txBody>
                  <a:tcPr marL="2172" marR="2172" marT="217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953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33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164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49885498"/>
                  </a:ext>
                </a:extLst>
              </a:tr>
              <a:tr h="303056"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Midline-J</a:t>
                      </a:r>
                      <a:b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</a:br>
                      <a: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(a)</a:t>
                      </a:r>
                    </a:p>
                  </a:txBody>
                  <a:tcPr marL="2172" marR="2172" marT="217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865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33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001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52323458"/>
                  </a:ext>
                </a:extLst>
              </a:tr>
              <a:tr h="303056"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Midline-J</a:t>
                      </a:r>
                      <a:b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</a:br>
                      <a: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(b)</a:t>
                      </a:r>
                    </a:p>
                  </a:txBody>
                  <a:tcPr marL="2172" marR="2172" marT="217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960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33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258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50356316"/>
                  </a:ext>
                </a:extLst>
              </a:tr>
              <a:tr h="303056"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Midline-J</a:t>
                      </a:r>
                      <a:b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</a:br>
                      <a: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diff</a:t>
                      </a:r>
                    </a:p>
                  </a:txBody>
                  <a:tcPr marL="2172" marR="2172" marT="217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981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33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815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36780605"/>
                  </a:ext>
                </a:extLst>
              </a:tr>
              <a:tr h="361852"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Midline-Mo</a:t>
                      </a:r>
                      <a:b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</a:br>
                      <a: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(a)</a:t>
                      </a:r>
                    </a:p>
                  </a:txBody>
                  <a:tcPr marL="2172" marR="2172" marT="217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971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33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505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94655987"/>
                  </a:ext>
                </a:extLst>
              </a:tr>
              <a:tr h="361852"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Midline-Mo</a:t>
                      </a:r>
                      <a:b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</a:br>
                      <a: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(b)</a:t>
                      </a:r>
                    </a:p>
                  </a:txBody>
                  <a:tcPr marL="2172" marR="2172" marT="217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976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33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655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24188655"/>
                  </a:ext>
                </a:extLst>
              </a:tr>
              <a:tr h="361852"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Midline-Mo</a:t>
                      </a:r>
                      <a:b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</a:br>
                      <a: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diff</a:t>
                      </a:r>
                    </a:p>
                  </a:txBody>
                  <a:tcPr marL="2172" marR="2172" marT="217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977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33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690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70677963"/>
                  </a:ext>
                </a:extLst>
              </a:tr>
              <a:tr h="241958"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Midline-U1</a:t>
                      </a:r>
                    </a:p>
                  </a:txBody>
                  <a:tcPr marL="2172" marR="2172" marT="217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917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33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015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82112528"/>
                  </a:ext>
                </a:extLst>
              </a:tr>
              <a:tr h="152549"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Go(a)-Me</a:t>
                      </a:r>
                    </a:p>
                  </a:txBody>
                  <a:tcPr marL="2172" marR="2172" marT="217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956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33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202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04676026"/>
                  </a:ext>
                </a:extLst>
              </a:tr>
              <a:tr h="152549"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Go(b)-Me</a:t>
                      </a:r>
                    </a:p>
                  </a:txBody>
                  <a:tcPr marL="2172" marR="2172" marT="217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961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33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285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61334402"/>
                  </a:ext>
                </a:extLst>
              </a:tr>
              <a:tr h="303056"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Go-Me</a:t>
                      </a:r>
                      <a:b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</a:br>
                      <a: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diff</a:t>
                      </a:r>
                    </a:p>
                  </a:txBody>
                  <a:tcPr marL="2172" marR="2172" marT="217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958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33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223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24504212"/>
                  </a:ext>
                </a:extLst>
              </a:tr>
              <a:tr h="241958"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Midline-Me</a:t>
                      </a:r>
                    </a:p>
                  </a:txBody>
                  <a:tcPr marL="2172" marR="2172" marT="217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885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33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002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78304236"/>
                  </a:ext>
                </a:extLst>
              </a:tr>
              <a:tr h="152549"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L6(a)-FP</a:t>
                      </a:r>
                    </a:p>
                  </a:txBody>
                  <a:tcPr marL="2172" marR="2172" marT="217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969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33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461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89119311"/>
                  </a:ext>
                </a:extLst>
              </a:tr>
              <a:tr h="152549"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L6(b)-FP’</a:t>
                      </a:r>
                    </a:p>
                  </a:txBody>
                  <a:tcPr marL="2172" marR="2172" marT="217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977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33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693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91199531"/>
                  </a:ext>
                </a:extLst>
              </a:tr>
              <a:tr h="241958"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L6(a)-FP diff</a:t>
                      </a:r>
                    </a:p>
                  </a:txBody>
                  <a:tcPr marL="2172" marR="2172" marT="217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972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33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524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34863414"/>
                  </a:ext>
                </a:extLst>
              </a:tr>
              <a:tr h="241958"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L6(a)-Midline</a:t>
                      </a:r>
                    </a:p>
                  </a:txBody>
                  <a:tcPr marL="2172" marR="2172" marT="217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989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33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977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71059099"/>
                  </a:ext>
                </a:extLst>
              </a:tr>
              <a:tr h="241958"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L6(b)-Midline</a:t>
                      </a:r>
                    </a:p>
                  </a:txBody>
                  <a:tcPr marL="2172" marR="2172" marT="217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978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33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730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37118970"/>
                  </a:ext>
                </a:extLst>
              </a:tr>
              <a:tr h="361852"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L6-Midline diff</a:t>
                      </a:r>
                    </a:p>
                  </a:txBody>
                  <a:tcPr marL="2172" marR="2172" marT="217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948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33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117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58896827"/>
                  </a:ext>
                </a:extLst>
              </a:tr>
              <a:tr h="152549"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MS Gothic" panose="020B0609070205080204" pitchFamily="49" charset="-128"/>
                          <a:ea typeface="MS Gothic" panose="020B0609070205080204" pitchFamily="49" charset="-128"/>
                        </a:rPr>
                        <a:t>∠</a:t>
                      </a:r>
                      <a: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Fmp</a:t>
                      </a:r>
                    </a:p>
                  </a:txBody>
                  <a:tcPr marL="2172" marR="2172" marT="217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825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33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000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28347119"/>
                  </a:ext>
                </a:extLst>
              </a:tr>
              <a:tr h="152549"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MS Gothic" panose="020B0609070205080204" pitchFamily="49" charset="-128"/>
                          <a:ea typeface="MS Gothic" panose="020B0609070205080204" pitchFamily="49" charset="-128"/>
                        </a:rPr>
                        <a:t>∠</a:t>
                      </a:r>
                      <a: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J</a:t>
                      </a:r>
                    </a:p>
                  </a:txBody>
                  <a:tcPr marL="2172" marR="2172" marT="217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857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33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000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75847772"/>
                  </a:ext>
                </a:extLst>
              </a:tr>
              <a:tr h="152549"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MS Gothic" panose="020B0609070205080204" pitchFamily="49" charset="-128"/>
                          <a:ea typeface="MS Gothic" panose="020B0609070205080204" pitchFamily="49" charset="-128"/>
                        </a:rPr>
                        <a:t>∠</a:t>
                      </a:r>
                      <a: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Ocl</a:t>
                      </a:r>
                    </a:p>
                  </a:txBody>
                  <a:tcPr marL="2172" marR="2172" marT="217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808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33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000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73441214"/>
                  </a:ext>
                </a:extLst>
              </a:tr>
              <a:tr h="306969"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MS Gothic" panose="020B0609070205080204" pitchFamily="49" charset="-128"/>
                          <a:ea typeface="MS Gothic" panose="020B0609070205080204" pitchFamily="49" charset="-128"/>
                        </a:rPr>
                        <a:t>∠</a:t>
                      </a:r>
                      <a: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Mea</a:t>
                      </a:r>
                    </a:p>
                  </a:txBody>
                  <a:tcPr marL="2172" marR="2172" marT="217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941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33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071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86201592"/>
                  </a:ext>
                </a:extLst>
              </a:tr>
              <a:tr h="687340"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volumetric asymmetry of the whole face</a:t>
                      </a:r>
                      <a: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MS Gothic" panose="020B0609070205080204" pitchFamily="49" charset="-128"/>
                          <a:ea typeface="MS Gothic" panose="020B0609070205080204" pitchFamily="49" charset="-128"/>
                        </a:rPr>
                        <a:t>（㎤）</a:t>
                      </a:r>
                      <a:endParaRPr lang="en" sz="1050" b="0" i="0" u="none" strike="noStrike">
                        <a:solidFill>
                          <a:srgbClr val="264A6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2172" marR="2172" marT="217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919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33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017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33473309"/>
                  </a:ext>
                </a:extLst>
              </a:tr>
              <a:tr h="787954"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volumetric asymmetry of the lower face</a:t>
                      </a:r>
                      <a: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MS Gothic" panose="020B0609070205080204" pitchFamily="49" charset="-128"/>
                          <a:ea typeface="MS Gothic" panose="020B0609070205080204" pitchFamily="49" charset="-128"/>
                        </a:rPr>
                        <a:t>（㎤）</a:t>
                      </a:r>
                      <a:endParaRPr lang="en" sz="1050" b="0" i="0" u="none" strike="noStrike">
                        <a:solidFill>
                          <a:srgbClr val="264A6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2172" marR="2172" marT="217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957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33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214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38581612"/>
                  </a:ext>
                </a:extLst>
              </a:tr>
              <a:tr h="721536"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volumetric asymmetry of the midface</a:t>
                      </a:r>
                      <a:r>
                        <a:rPr lang="en" sz="1050" b="0" i="0" u="none" strike="noStrike">
                          <a:solidFill>
                            <a:srgbClr val="264A60"/>
                          </a:solidFill>
                          <a:effectLst/>
                          <a:latin typeface="MS Gothic" panose="020B0609070205080204" pitchFamily="49" charset="-128"/>
                          <a:ea typeface="MS Gothic" panose="020B0609070205080204" pitchFamily="49" charset="-128"/>
                        </a:rPr>
                        <a:t>（㎤）</a:t>
                      </a:r>
                      <a:endParaRPr lang="en" sz="1050" b="0" i="0" u="none" strike="noStrike">
                        <a:solidFill>
                          <a:srgbClr val="264A6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2172" marR="2172" marT="217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964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33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>
                          <a:solidFill>
                            <a:srgbClr val="010205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</a:rPr>
                        <a:t>0.326</a:t>
                      </a:r>
                    </a:p>
                  </a:txBody>
                  <a:tcPr marL="2172" marR="2172" marT="2172" marB="0" anchor="ctr">
                    <a:lnL w="6350" cap="flat" cmpd="sng" algn="ctr">
                      <a:solidFill>
                        <a:srgbClr val="E0E0E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EAEA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9960111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372712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09528DCB-520D-29B0-C83E-53A36B8A775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65912774"/>
              </p:ext>
            </p:extLst>
          </p:nvPr>
        </p:nvGraphicFramePr>
        <p:xfrm>
          <a:off x="1098394" y="1916907"/>
          <a:ext cx="4661210" cy="835818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32242">
                  <a:extLst>
                    <a:ext uri="{9D8B030D-6E8A-4147-A177-3AD203B41FA5}">
                      <a16:colId xmlns:a16="http://schemas.microsoft.com/office/drawing/2014/main" val="3719768168"/>
                    </a:ext>
                  </a:extLst>
                </a:gridCol>
                <a:gridCol w="932242">
                  <a:extLst>
                    <a:ext uri="{9D8B030D-6E8A-4147-A177-3AD203B41FA5}">
                      <a16:colId xmlns:a16="http://schemas.microsoft.com/office/drawing/2014/main" val="3646730132"/>
                    </a:ext>
                  </a:extLst>
                </a:gridCol>
                <a:gridCol w="932242">
                  <a:extLst>
                    <a:ext uri="{9D8B030D-6E8A-4147-A177-3AD203B41FA5}">
                      <a16:colId xmlns:a16="http://schemas.microsoft.com/office/drawing/2014/main" val="1446652914"/>
                    </a:ext>
                  </a:extLst>
                </a:gridCol>
                <a:gridCol w="932242">
                  <a:extLst>
                    <a:ext uri="{9D8B030D-6E8A-4147-A177-3AD203B41FA5}">
                      <a16:colId xmlns:a16="http://schemas.microsoft.com/office/drawing/2014/main" val="2448392184"/>
                    </a:ext>
                  </a:extLst>
                </a:gridCol>
                <a:gridCol w="932242">
                  <a:extLst>
                    <a:ext uri="{9D8B030D-6E8A-4147-A177-3AD203B41FA5}">
                      <a16:colId xmlns:a16="http://schemas.microsoft.com/office/drawing/2014/main" val="3940760711"/>
                    </a:ext>
                  </a:extLst>
                </a:gridCol>
              </a:tblGrid>
              <a:tr h="143504">
                <a:tc>
                  <a:txBody>
                    <a:bodyPr/>
                    <a:lstStyle/>
                    <a:p>
                      <a:pPr algn="ctr" fontAlgn="t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Region</a:t>
                      </a:r>
                      <a:endParaRPr lang="en" sz="1200" b="1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Predictor</a:t>
                      </a:r>
                      <a:endParaRPr lang="en" sz="1200" b="1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r</a:t>
                      </a:r>
                      <a:endParaRPr lang="en" sz="1200" b="1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" sz="1200" u="none" strike="noStrike" dirty="0">
                          <a:effectLst/>
                          <a:latin typeface="Palatino Linotype" panose="02040502050505030304" pitchFamily="18" charset="0"/>
                        </a:rPr>
                        <a:t>R</a:t>
                      </a:r>
                      <a:r>
                        <a:rPr lang="en" sz="1200" u="none" strike="noStrike" baseline="30000" dirty="0">
                          <a:effectLst/>
                          <a:latin typeface="Palatino Linotype" panose="02040502050505030304" pitchFamily="18" charset="0"/>
                        </a:rPr>
                        <a:t>2</a:t>
                      </a:r>
                      <a:endParaRPr lang="en" sz="1200" b="1" i="0" u="none" strike="noStrike" baseline="30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p</a:t>
                      </a:r>
                      <a:endParaRPr lang="en" sz="1200" b="1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/>
                </a:tc>
                <a:extLst>
                  <a:ext uri="{0D108BD9-81ED-4DB2-BD59-A6C34878D82A}">
                    <a16:rowId xmlns:a16="http://schemas.microsoft.com/office/drawing/2014/main" val="673000320"/>
                  </a:ext>
                </a:extLst>
              </a:tr>
              <a:tr h="143504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Whole 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o lin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-0.064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04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 dirty="0">
                          <a:effectLst/>
                          <a:latin typeface="Palatino Linotype" panose="02040502050505030304" pitchFamily="18" charset="0"/>
                        </a:rPr>
                        <a:t>0.724 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2815262773"/>
                  </a:ext>
                </a:extLst>
              </a:tr>
              <a:tr h="143504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Whole 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FP (a)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01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00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997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2482716385"/>
                  </a:ext>
                </a:extLst>
              </a:tr>
              <a:tr h="143504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Whole 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FP (b)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-0.070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05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701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3137831322"/>
                  </a:ext>
                </a:extLst>
              </a:tr>
              <a:tr h="143504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Whole 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FP diff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93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09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607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692590812"/>
                  </a:ext>
                </a:extLst>
              </a:tr>
              <a:tr h="278295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Whole 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o line-J (a)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-0.107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11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 dirty="0">
                          <a:effectLst/>
                          <a:latin typeface="Palatino Linotype" panose="02040502050505030304" pitchFamily="18" charset="0"/>
                        </a:rPr>
                        <a:t>0.554 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1327427817"/>
                  </a:ext>
                </a:extLst>
              </a:tr>
              <a:tr h="278295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Whole 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o line-J (b)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-0.065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04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719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1514636597"/>
                  </a:ext>
                </a:extLst>
              </a:tr>
              <a:tr h="278295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 dirty="0">
                          <a:effectLst/>
                          <a:latin typeface="Palatino Linotype" panose="02040502050505030304" pitchFamily="18" charset="0"/>
                        </a:rPr>
                        <a:t>Whole face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o-line-J diff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-0.083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07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647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451864938"/>
                  </a:ext>
                </a:extLst>
              </a:tr>
              <a:tr h="278295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Whole 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o line-Mo (a)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-0.095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09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600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1020604917"/>
                  </a:ext>
                </a:extLst>
              </a:tr>
              <a:tr h="278295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Whole 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o line-Mo (b)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08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00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964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514436415"/>
                  </a:ext>
                </a:extLst>
              </a:tr>
              <a:tr h="278295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Whole 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o line-Mo diff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-0.307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95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82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3570823117"/>
                  </a:ext>
                </a:extLst>
              </a:tr>
              <a:tr h="278295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Whole 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Midline-J (a)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414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171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17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3345748188"/>
                  </a:ext>
                </a:extLst>
              </a:tr>
              <a:tr h="278295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Whole 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Midline-J (b)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78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06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668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3388089767"/>
                  </a:ext>
                </a:extLst>
              </a:tr>
              <a:tr h="278295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Whole 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Midline-J diff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510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260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02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4234159390"/>
                  </a:ext>
                </a:extLst>
              </a:tr>
              <a:tr h="278295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Whole 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Midline-Mo (a)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424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179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14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2826644202"/>
                  </a:ext>
                </a:extLst>
              </a:tr>
              <a:tr h="278295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Whole 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Midline-Mo (b)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-0.465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216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06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2019326054"/>
                  </a:ext>
                </a:extLst>
              </a:tr>
              <a:tr h="278295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Whole 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Midline-Mo diff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594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353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00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671022597"/>
                  </a:ext>
                </a:extLst>
              </a:tr>
              <a:tr h="143504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Whole 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Midline-U1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277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77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119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4129292567"/>
                  </a:ext>
                </a:extLst>
              </a:tr>
              <a:tr h="143504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Whole 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Go(a)-M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-0.146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21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416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994255816"/>
                  </a:ext>
                </a:extLst>
              </a:tr>
              <a:tr h="143504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Whole 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Go(b)-M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109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12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547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3462365853"/>
                  </a:ext>
                </a:extLst>
              </a:tr>
              <a:tr h="143504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Whole 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Go-Me diff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-0.381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145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29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3263191338"/>
                  </a:ext>
                </a:extLst>
              </a:tr>
              <a:tr h="143504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Whole 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Midline-M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794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631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00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1511608485"/>
                  </a:ext>
                </a:extLst>
              </a:tr>
              <a:tr h="143504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Whole 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6(a)-FP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-0.052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03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773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1110658344"/>
                  </a:ext>
                </a:extLst>
              </a:tr>
              <a:tr h="143504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Whole 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6(b)-FP’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-0.099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10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585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3614378799"/>
                  </a:ext>
                </a:extLst>
              </a:tr>
              <a:tr h="278295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Whole 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6(a)-FP diff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14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00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938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1462156379"/>
                  </a:ext>
                </a:extLst>
              </a:tr>
              <a:tr h="278295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Whole 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6(a)-Midlin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496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246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03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2779748252"/>
                  </a:ext>
                </a:extLst>
              </a:tr>
              <a:tr h="278295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Whole 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6(b)-Midlin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-0.512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263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02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2104556071"/>
                  </a:ext>
                </a:extLst>
              </a:tr>
              <a:tr h="278295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Whole 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6-Midline diff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645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416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00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105770934"/>
                  </a:ext>
                </a:extLst>
              </a:tr>
              <a:tr h="143504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Whole 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∠Fmp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186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35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300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575152967"/>
                  </a:ext>
                </a:extLst>
              </a:tr>
              <a:tr h="143504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Whole 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∠J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121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15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502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3514713577"/>
                  </a:ext>
                </a:extLst>
              </a:tr>
              <a:tr h="143504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Whole 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∠Ocl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51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03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778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679823490"/>
                  </a:ext>
                </a:extLst>
              </a:tr>
              <a:tr h="143504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Whole 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∠Mea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585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343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 dirty="0">
                          <a:effectLst/>
                          <a:latin typeface="Palatino Linotype" panose="02040502050505030304" pitchFamily="18" charset="0"/>
                        </a:rPr>
                        <a:t>0.000 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3677295732"/>
                  </a:ext>
                </a:extLst>
              </a:tr>
            </a:tbl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E121EB66-B1CB-B5C8-410F-2A228438CFAC}"/>
              </a:ext>
            </a:extLst>
          </p:cNvPr>
          <p:cNvSpPr txBox="1"/>
          <p:nvPr/>
        </p:nvSpPr>
        <p:spPr>
          <a:xfrm>
            <a:off x="491892" y="342268"/>
            <a:ext cx="587421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able S2: Correlation coefficients between cephalometric variables and volumetric asymmetry subdivided by (a) whole face </a:t>
            </a:r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908462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1FCB4B3A-12DB-19C3-97B2-07D65CC899E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08009923"/>
              </p:ext>
            </p:extLst>
          </p:nvPr>
        </p:nvGraphicFramePr>
        <p:xfrm>
          <a:off x="786162" y="2297519"/>
          <a:ext cx="5285675" cy="7596961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057135">
                  <a:extLst>
                    <a:ext uri="{9D8B030D-6E8A-4147-A177-3AD203B41FA5}">
                      <a16:colId xmlns:a16="http://schemas.microsoft.com/office/drawing/2014/main" val="4009079729"/>
                    </a:ext>
                  </a:extLst>
                </a:gridCol>
                <a:gridCol w="1057135">
                  <a:extLst>
                    <a:ext uri="{9D8B030D-6E8A-4147-A177-3AD203B41FA5}">
                      <a16:colId xmlns:a16="http://schemas.microsoft.com/office/drawing/2014/main" val="3175449934"/>
                    </a:ext>
                  </a:extLst>
                </a:gridCol>
                <a:gridCol w="1057135">
                  <a:extLst>
                    <a:ext uri="{9D8B030D-6E8A-4147-A177-3AD203B41FA5}">
                      <a16:colId xmlns:a16="http://schemas.microsoft.com/office/drawing/2014/main" val="1695082901"/>
                    </a:ext>
                  </a:extLst>
                </a:gridCol>
                <a:gridCol w="1057135">
                  <a:extLst>
                    <a:ext uri="{9D8B030D-6E8A-4147-A177-3AD203B41FA5}">
                      <a16:colId xmlns:a16="http://schemas.microsoft.com/office/drawing/2014/main" val="2500351765"/>
                    </a:ext>
                  </a:extLst>
                </a:gridCol>
                <a:gridCol w="1057135">
                  <a:extLst>
                    <a:ext uri="{9D8B030D-6E8A-4147-A177-3AD203B41FA5}">
                      <a16:colId xmlns:a16="http://schemas.microsoft.com/office/drawing/2014/main" val="2363182158"/>
                    </a:ext>
                  </a:extLst>
                </a:gridCol>
              </a:tblGrid>
              <a:tr h="143504">
                <a:tc>
                  <a:txBody>
                    <a:bodyPr/>
                    <a:lstStyle/>
                    <a:p>
                      <a:pPr algn="ctr" fontAlgn="t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Region</a:t>
                      </a:r>
                      <a:endParaRPr lang="en" sz="1200" b="1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Predictor</a:t>
                      </a:r>
                      <a:endParaRPr lang="en" sz="1200" b="1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r</a:t>
                      </a:r>
                      <a:endParaRPr lang="en" sz="1200" b="1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" sz="1200" u="none" strike="noStrike" dirty="0">
                          <a:effectLst/>
                          <a:latin typeface="Palatino Linotype" panose="02040502050505030304" pitchFamily="18" charset="0"/>
                        </a:rPr>
                        <a:t>R</a:t>
                      </a:r>
                      <a:r>
                        <a:rPr lang="en" sz="1200" u="none" strike="noStrike" baseline="30000" dirty="0">
                          <a:effectLst/>
                          <a:latin typeface="Palatino Linotype" panose="02040502050505030304" pitchFamily="18" charset="0"/>
                        </a:rPr>
                        <a:t>2</a:t>
                      </a:r>
                      <a:endParaRPr lang="en" sz="1200" b="1" i="0" u="none" strike="noStrike" baseline="30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p</a:t>
                      </a:r>
                      <a:endParaRPr lang="en" sz="1200" b="1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/>
                </a:tc>
                <a:extLst>
                  <a:ext uri="{0D108BD9-81ED-4DB2-BD59-A6C34878D82A}">
                    <a16:rowId xmlns:a16="http://schemas.microsoft.com/office/drawing/2014/main" val="104853548"/>
                  </a:ext>
                </a:extLst>
              </a:tr>
              <a:tr h="143504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ower 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o lin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-0.016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00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 dirty="0">
                          <a:effectLst/>
                          <a:latin typeface="Palatino Linotype" panose="02040502050505030304" pitchFamily="18" charset="0"/>
                        </a:rPr>
                        <a:t>0.931 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4086193436"/>
                  </a:ext>
                </a:extLst>
              </a:tr>
              <a:tr h="143504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ower 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FP (a)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59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03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745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3915101008"/>
                  </a:ext>
                </a:extLst>
              </a:tr>
              <a:tr h="143504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ower 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FP (b)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-0.006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00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974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4115451894"/>
                  </a:ext>
                </a:extLst>
              </a:tr>
              <a:tr h="143504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ower 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FP diff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90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08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618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3186225690"/>
                  </a:ext>
                </a:extLst>
              </a:tr>
              <a:tr h="278295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ower 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o line-J (a)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-0.083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07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 dirty="0">
                          <a:effectLst/>
                          <a:latin typeface="Palatino Linotype" panose="02040502050505030304" pitchFamily="18" charset="0"/>
                        </a:rPr>
                        <a:t>0.644 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2110648277"/>
                  </a:ext>
                </a:extLst>
              </a:tr>
              <a:tr h="278295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ower 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o line-J (b)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-0.055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03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760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552241293"/>
                  </a:ext>
                </a:extLst>
              </a:tr>
              <a:tr h="278295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ower 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o-line-J diff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-0.054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03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764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278972425"/>
                  </a:ext>
                </a:extLst>
              </a:tr>
              <a:tr h="278295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ower 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o line-Mo (a)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-0.064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04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722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8337914"/>
                  </a:ext>
                </a:extLst>
              </a:tr>
              <a:tr h="278295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ower 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o line-Mo (b)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44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02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807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2327425983"/>
                  </a:ext>
                </a:extLst>
              </a:tr>
              <a:tr h="278295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ower 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o line-Mo diff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-0.326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106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64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699246538"/>
                  </a:ext>
                </a:extLst>
              </a:tr>
              <a:tr h="278295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ower 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Midline-J (a)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354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125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43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3734125991"/>
                  </a:ext>
                </a:extLst>
              </a:tr>
              <a:tr h="278295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ower 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Midline-J (b)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37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01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837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589563025"/>
                  </a:ext>
                </a:extLst>
              </a:tr>
              <a:tr h="278295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ower 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Midline-J diff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475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225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05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2530292343"/>
                  </a:ext>
                </a:extLst>
              </a:tr>
              <a:tr h="278295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ower 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Midline-Mo (a)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410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168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18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2537971016"/>
                  </a:ext>
                </a:extLst>
              </a:tr>
              <a:tr h="278295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ower 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Midline-Mo (b)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-0.399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159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21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2894093788"/>
                  </a:ext>
                </a:extLst>
              </a:tr>
              <a:tr h="278295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ower 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Midline-Mo diff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543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294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01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2922753550"/>
                  </a:ext>
                </a:extLst>
              </a:tr>
              <a:tr h="143504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ower 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Midline-U1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339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115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54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3757302060"/>
                  </a:ext>
                </a:extLst>
              </a:tr>
              <a:tr h="143504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ower 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Go(a)-M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-0.202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41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260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3316248321"/>
                  </a:ext>
                </a:extLst>
              </a:tr>
              <a:tr h="143504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ower 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Go(b)-M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82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07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651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1226602044"/>
                  </a:ext>
                </a:extLst>
              </a:tr>
              <a:tr h="143504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ower 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Go-Me diff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-0.432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186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12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1070948500"/>
                  </a:ext>
                </a:extLst>
              </a:tr>
              <a:tr h="143504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ower 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Midline-M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793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629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00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2273724082"/>
                  </a:ext>
                </a:extLst>
              </a:tr>
              <a:tr h="143504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ower 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6(a)-FP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-0.038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01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835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3955807455"/>
                  </a:ext>
                </a:extLst>
              </a:tr>
              <a:tr h="143504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ower 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6(b)-FP’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-0.114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13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526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1198201290"/>
                  </a:ext>
                </a:extLst>
              </a:tr>
              <a:tr h="278295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ower 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6(a)-FP diff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41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02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819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124718853"/>
                  </a:ext>
                </a:extLst>
              </a:tr>
              <a:tr h="278295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ower 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6(a)-Midlin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487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237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04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261254198"/>
                  </a:ext>
                </a:extLst>
              </a:tr>
              <a:tr h="278295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ower 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6(b)-Midlin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-0.450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203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09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2902388900"/>
                  </a:ext>
                </a:extLst>
              </a:tr>
              <a:tr h="278295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ower 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6-Midline diff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602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362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00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1035290649"/>
                  </a:ext>
                </a:extLst>
              </a:tr>
              <a:tr h="143504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ower 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∠Fmp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185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34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303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16785320"/>
                  </a:ext>
                </a:extLst>
              </a:tr>
              <a:tr h="143504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ower 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∠J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136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19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449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3450457765"/>
                  </a:ext>
                </a:extLst>
              </a:tr>
              <a:tr h="143504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ower 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∠Ocl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21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00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908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1651539062"/>
                  </a:ext>
                </a:extLst>
              </a:tr>
              <a:tr h="143504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ower 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∠Mea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540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292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 dirty="0">
                          <a:effectLst/>
                          <a:latin typeface="Palatino Linotype" panose="02040502050505030304" pitchFamily="18" charset="0"/>
                        </a:rPr>
                        <a:t>0.001 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1856238680"/>
                  </a:ext>
                </a:extLst>
              </a:tr>
            </a:tbl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ABE915DF-0573-FB1A-BCC1-23B30B539605}"/>
              </a:ext>
            </a:extLst>
          </p:cNvPr>
          <p:cNvSpPr txBox="1"/>
          <p:nvPr/>
        </p:nvSpPr>
        <p:spPr>
          <a:xfrm>
            <a:off x="786162" y="212181"/>
            <a:ext cx="561463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able S2: Correlation coefficients between cephalometric variables and volumetric asymmetry subdivided by  (b) lower face</a:t>
            </a:r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331828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C64C68EB-E3BB-FE2D-32E9-9C5080F56C8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24982644"/>
              </p:ext>
            </p:extLst>
          </p:nvPr>
        </p:nvGraphicFramePr>
        <p:xfrm>
          <a:off x="1410627" y="1587585"/>
          <a:ext cx="4036745" cy="901683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07349">
                  <a:extLst>
                    <a:ext uri="{9D8B030D-6E8A-4147-A177-3AD203B41FA5}">
                      <a16:colId xmlns:a16="http://schemas.microsoft.com/office/drawing/2014/main" val="1070761183"/>
                    </a:ext>
                  </a:extLst>
                </a:gridCol>
                <a:gridCol w="807349">
                  <a:extLst>
                    <a:ext uri="{9D8B030D-6E8A-4147-A177-3AD203B41FA5}">
                      <a16:colId xmlns:a16="http://schemas.microsoft.com/office/drawing/2014/main" val="2151177020"/>
                    </a:ext>
                  </a:extLst>
                </a:gridCol>
                <a:gridCol w="807349">
                  <a:extLst>
                    <a:ext uri="{9D8B030D-6E8A-4147-A177-3AD203B41FA5}">
                      <a16:colId xmlns:a16="http://schemas.microsoft.com/office/drawing/2014/main" val="152611500"/>
                    </a:ext>
                  </a:extLst>
                </a:gridCol>
                <a:gridCol w="807349">
                  <a:extLst>
                    <a:ext uri="{9D8B030D-6E8A-4147-A177-3AD203B41FA5}">
                      <a16:colId xmlns:a16="http://schemas.microsoft.com/office/drawing/2014/main" val="3263681276"/>
                    </a:ext>
                  </a:extLst>
                </a:gridCol>
                <a:gridCol w="807349">
                  <a:extLst>
                    <a:ext uri="{9D8B030D-6E8A-4147-A177-3AD203B41FA5}">
                      <a16:colId xmlns:a16="http://schemas.microsoft.com/office/drawing/2014/main" val="224319563"/>
                    </a:ext>
                  </a:extLst>
                </a:gridCol>
              </a:tblGrid>
              <a:tr h="143504">
                <a:tc>
                  <a:txBody>
                    <a:bodyPr/>
                    <a:lstStyle/>
                    <a:p>
                      <a:pPr algn="ctr" fontAlgn="t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Region</a:t>
                      </a:r>
                      <a:endParaRPr lang="en" sz="1200" b="1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Predictor</a:t>
                      </a:r>
                      <a:endParaRPr lang="en" sz="1200" b="1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r</a:t>
                      </a:r>
                      <a:endParaRPr lang="en" sz="1200" b="1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" sz="1200" u="none" strike="noStrike" dirty="0">
                          <a:effectLst/>
                          <a:latin typeface="Palatino Linotype" panose="02040502050505030304" pitchFamily="18" charset="0"/>
                        </a:rPr>
                        <a:t>R</a:t>
                      </a:r>
                      <a:r>
                        <a:rPr lang="en" sz="1200" u="none" strike="noStrike" baseline="30000" dirty="0">
                          <a:effectLst/>
                          <a:latin typeface="Palatino Linotype" panose="02040502050505030304" pitchFamily="18" charset="0"/>
                        </a:rPr>
                        <a:t>2</a:t>
                      </a:r>
                      <a:endParaRPr lang="en" sz="1200" b="1" i="0" u="none" strike="noStrike" baseline="30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p</a:t>
                      </a:r>
                      <a:endParaRPr lang="en" sz="1200" b="1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/>
                </a:tc>
                <a:extLst>
                  <a:ext uri="{0D108BD9-81ED-4DB2-BD59-A6C34878D82A}">
                    <a16:rowId xmlns:a16="http://schemas.microsoft.com/office/drawing/2014/main" val="1051343426"/>
                  </a:ext>
                </a:extLst>
              </a:tr>
              <a:tr h="143504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Mid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o lin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74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05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 dirty="0">
                          <a:effectLst/>
                          <a:latin typeface="Palatino Linotype" panose="02040502050505030304" pitchFamily="18" charset="0"/>
                        </a:rPr>
                        <a:t>0.682 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3964409159"/>
                  </a:ext>
                </a:extLst>
              </a:tr>
              <a:tr h="143504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Mid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FP (a)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18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00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920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1485347140"/>
                  </a:ext>
                </a:extLst>
              </a:tr>
              <a:tr h="143504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Mid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FP (b)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-0.078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06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667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3544401418"/>
                  </a:ext>
                </a:extLst>
              </a:tr>
              <a:tr h="143504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Mid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FP diff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128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16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476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390005547"/>
                  </a:ext>
                </a:extLst>
              </a:tr>
              <a:tr h="278295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Mid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o line-J (a)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-0.024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01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 dirty="0">
                          <a:effectLst/>
                          <a:latin typeface="Palatino Linotype" panose="02040502050505030304" pitchFamily="18" charset="0"/>
                        </a:rPr>
                        <a:t>0.896 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378705958"/>
                  </a:ext>
                </a:extLst>
              </a:tr>
              <a:tr h="278295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Mid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o line-J (b)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-0.003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00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988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1938005944"/>
                  </a:ext>
                </a:extLst>
              </a:tr>
              <a:tr h="278295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Mid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o-line-J diff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-0.047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02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797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1702253629"/>
                  </a:ext>
                </a:extLst>
              </a:tr>
              <a:tr h="278295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Mid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o line-Mo (a)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-0.090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08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620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1527784054"/>
                  </a:ext>
                </a:extLst>
              </a:tr>
              <a:tr h="278295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Mid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o line-Mo (b)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-0.060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04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742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2443257382"/>
                  </a:ext>
                </a:extLst>
              </a:tr>
              <a:tr h="278295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Mid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o line-Mo diff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-0.088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08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628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2773457509"/>
                  </a:ext>
                </a:extLst>
              </a:tr>
              <a:tr h="278295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Mid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Midline-J (a)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431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185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12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2028773005"/>
                  </a:ext>
                </a:extLst>
              </a:tr>
              <a:tr h="278295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Mid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Midline-J (b)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229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52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200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1413245056"/>
                  </a:ext>
                </a:extLst>
              </a:tr>
              <a:tr h="278295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Mid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Midline-J diff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334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112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58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2358821504"/>
                  </a:ext>
                </a:extLst>
              </a:tr>
              <a:tr h="278295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Mid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Midline-Mo (a)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122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15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499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154787734"/>
                  </a:ext>
                </a:extLst>
              </a:tr>
              <a:tr h="278295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Mid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Midline-Mo (b)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-0.202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41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259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427372801"/>
                  </a:ext>
                </a:extLst>
              </a:tr>
              <a:tr h="278295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Mid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Midline-Mo diff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215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46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229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1471070074"/>
                  </a:ext>
                </a:extLst>
              </a:tr>
              <a:tr h="143504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Mid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Midline-U1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38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01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832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3584846976"/>
                  </a:ext>
                </a:extLst>
              </a:tr>
              <a:tr h="143504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Mid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Go(a)-M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109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12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546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1542785476"/>
                  </a:ext>
                </a:extLst>
              </a:tr>
              <a:tr h="143504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Mid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Go(b)-M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168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28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349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1344695747"/>
                  </a:ext>
                </a:extLst>
              </a:tr>
              <a:tr h="143504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Mid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Go-Me diff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-0.057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03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752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2473415749"/>
                  </a:ext>
                </a:extLst>
              </a:tr>
              <a:tr h="143504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Mid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Midline-M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359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129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40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1212261716"/>
                  </a:ext>
                </a:extLst>
              </a:tr>
              <a:tr h="143504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Mid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6(a)-FP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106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11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556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354069621"/>
                  </a:ext>
                </a:extLst>
              </a:tr>
              <a:tr h="143504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Mid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6(b)-FP’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00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00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1.000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2713813489"/>
                  </a:ext>
                </a:extLst>
              </a:tr>
              <a:tr h="278295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Mid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6(a)-FP diff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116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13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521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2544265243"/>
                  </a:ext>
                </a:extLst>
              </a:tr>
              <a:tr h="278295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Mid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6(a)-Midlin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169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29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346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3488168011"/>
                  </a:ext>
                </a:extLst>
              </a:tr>
              <a:tr h="278295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Mid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6(b)-Midlin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-0.246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61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167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3948553323"/>
                  </a:ext>
                </a:extLst>
              </a:tr>
              <a:tr h="278295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Mid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L6-Midline diff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263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69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140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2276141611"/>
                  </a:ext>
                </a:extLst>
              </a:tr>
              <a:tr h="143504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Mid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∠Fmp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-0.043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02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810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1734637992"/>
                  </a:ext>
                </a:extLst>
              </a:tr>
              <a:tr h="143504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Mid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∠J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-0.117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14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515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3574713699"/>
                  </a:ext>
                </a:extLst>
              </a:tr>
              <a:tr h="143504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Mid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∠Ocl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03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00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985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3371349877"/>
                  </a:ext>
                </a:extLst>
              </a:tr>
              <a:tr h="143504"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Midfac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u="none" strike="noStrike">
                          <a:effectLst/>
                          <a:latin typeface="Palatino Linotype" panose="02040502050505030304" pitchFamily="18" charset="0"/>
                        </a:rPr>
                        <a:t>∠Mea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189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>
                          <a:effectLst/>
                          <a:latin typeface="Palatino Linotype" panose="02040502050505030304" pitchFamily="18" charset="0"/>
                        </a:rPr>
                        <a:t>0.036 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200" u="none" strike="noStrike" dirty="0">
                          <a:effectLst/>
                          <a:latin typeface="Palatino Linotype" panose="02040502050505030304" pitchFamily="18" charset="0"/>
                        </a:rPr>
                        <a:t>0.293 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ＭＳ Ｐゴシック" panose="020B0600070205080204" pitchFamily="34" charset="-128"/>
                      </a:endParaRPr>
                    </a:p>
                  </a:txBody>
                  <a:tcPr marL="7688" marR="7688" marT="7688" marB="0" anchor="b"/>
                </a:tc>
                <a:extLst>
                  <a:ext uri="{0D108BD9-81ED-4DB2-BD59-A6C34878D82A}">
                    <a16:rowId xmlns:a16="http://schemas.microsoft.com/office/drawing/2014/main" val="2096909526"/>
                  </a:ext>
                </a:extLst>
              </a:tr>
            </a:tbl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A18057DB-3BC7-1F35-0697-38565A7FCCDB}"/>
              </a:ext>
            </a:extLst>
          </p:cNvPr>
          <p:cNvSpPr txBox="1"/>
          <p:nvPr/>
        </p:nvSpPr>
        <p:spPr>
          <a:xfrm>
            <a:off x="853070" y="304091"/>
            <a:ext cx="482847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able S2: Correlation coefficients between cephalometric variables and volumetric asymmetry subdivided by (c) midface</a:t>
            </a:r>
            <a:r>
              <a:rPr lang="ja-JP" altLang="ja-JP">
                <a:effectLst/>
              </a:rPr>
              <a:t> </a:t>
            </a:r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64599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1</TotalTime>
  <Words>1147</Words>
  <Application>Microsoft Macintosh PowerPoint</Application>
  <PresentationFormat>ワイド画面</PresentationFormat>
  <Paragraphs>627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10" baseType="lpstr">
      <vt:lpstr>MS Gothic</vt:lpstr>
      <vt:lpstr>Arial</vt:lpstr>
      <vt:lpstr>Calibri</vt:lpstr>
      <vt:lpstr>Calibri Light</vt:lpstr>
      <vt:lpstr>Palatino Linotype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雄大 新保</dc:creator>
  <cp:lastModifiedBy>雄大 新保</cp:lastModifiedBy>
  <cp:revision>6</cp:revision>
  <dcterms:created xsi:type="dcterms:W3CDTF">2025-08-28T22:21:27Z</dcterms:created>
  <dcterms:modified xsi:type="dcterms:W3CDTF">2025-09-15T23:55:00Z</dcterms:modified>
</cp:coreProperties>
</file>